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7"/>
  </p:notesMasterIdLst>
  <p:sldIdLst>
    <p:sldId id="256" r:id="rId2"/>
    <p:sldId id="257" r:id="rId3"/>
    <p:sldId id="266" r:id="rId4"/>
    <p:sldId id="261" r:id="rId5"/>
    <p:sldId id="267" r:id="rId6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íriam Rosás" initials="MR" lastIdx="2" clrIdx="0">
    <p:extLst>
      <p:ext uri="{19B8F6BF-5375-455C-9EA6-DF929625EA0E}">
        <p15:presenceInfo xmlns:p15="http://schemas.microsoft.com/office/powerpoint/2012/main" userId="f891f4f9134467ac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08AA3"/>
    <a:srgbClr val="C29E9F"/>
    <a:srgbClr val="8ECC9E"/>
    <a:srgbClr val="D3D5B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E8034E78-7F5D-4C2E-B375-FC64B27BC917}" styleName="Estilo oscuro 1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dk1">
              <a:tint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dk1">
              <a:tint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dk1">
              <a:tint val="6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8493"/>
    <p:restoredTop sz="95144"/>
  </p:normalViewPr>
  <p:slideViewPr>
    <p:cSldViewPr snapToGrid="0" snapToObjects="1">
      <p:cViewPr varScale="1">
        <p:scale>
          <a:sx n="92" d="100"/>
          <a:sy n="92" d="100"/>
        </p:scale>
        <p:origin x="114" y="4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ommentAuthors" Target="commentAuthor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3F835EA-5762-9D41-AD0A-A0DDD8F783A0}" type="datetimeFigureOut">
              <a:rPr lang="es-ES" smtClean="0"/>
              <a:t>02/03/2020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0483B3A-1C11-DC4C-9BE0-5DD0C071F5C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6262318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0483B3A-1C11-DC4C-9BE0-5DD0C071F5C1}" type="slidenum">
              <a:rPr lang="es-ES" smtClean="0"/>
              <a:t>1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485718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xmlns="" id="{9BA91237-E62D-1E46-8210-72C05C5257C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xmlns="" id="{B081F2A1-71A6-504B-9A31-274E21F15EF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xmlns="" id="{7E76667C-8938-3B44-8CA5-4747B3E6E8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461A81-977A-3C44-B9AA-252E0BC27F59}" type="datetimeFigureOut">
              <a:rPr lang="es-ES" smtClean="0"/>
              <a:t>02/03/2020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xmlns="" id="{EBFEFDD0-3353-2647-A18A-CAC963607F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xmlns="" id="{D6E141C7-DFEB-5543-A781-F57A442262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F56985-B2F4-D946-993F-F387E79CA1D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900000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xmlns="" id="{FF2E0971-60F6-B24B-B6F2-1F2E07814C5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xmlns="" id="{F3364D88-A661-1749-BEFB-7E91A2628E4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xmlns="" id="{3CD11E45-DAAA-DC4E-8C08-2163AB83EA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461A81-977A-3C44-B9AA-252E0BC27F59}" type="datetimeFigureOut">
              <a:rPr lang="es-ES" smtClean="0"/>
              <a:t>02/03/2020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xmlns="" id="{CB78F1C0-9F3B-EE4D-8856-FE1BF21016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xmlns="" id="{1C536ED6-0224-7F40-8402-4E2EB98B11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F56985-B2F4-D946-993F-F387E79CA1D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406341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xmlns="" id="{A2CC8A31-8F6C-C745-A071-7F4359384BB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xmlns="" id="{C75C0992-6936-AD48-8D2D-EBFFD971443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xmlns="" id="{E284B31D-E172-EC46-8B98-D8ADD25AAA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461A81-977A-3C44-B9AA-252E0BC27F59}" type="datetimeFigureOut">
              <a:rPr lang="es-ES" smtClean="0"/>
              <a:t>02/03/2020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xmlns="" id="{75426DAE-F87C-884C-9E06-36CEA00E36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xmlns="" id="{946ACD43-86DC-974A-96BD-5813948D56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F56985-B2F4-D946-993F-F387E79CA1D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41233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xmlns="" id="{AF1605B5-FF5A-CE42-93BC-377F63DD18F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xmlns="" id="{E5CF2D4B-E962-B442-AFAF-446AEE8F3D0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xmlns="" id="{35F4F254-A911-A04F-B76B-A6B086D528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461A81-977A-3C44-B9AA-252E0BC27F59}" type="datetimeFigureOut">
              <a:rPr lang="es-ES" smtClean="0"/>
              <a:t>02/03/2020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xmlns="" id="{1207DAB7-FAAC-D146-8E7B-A2A9EA3EB4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xmlns="" id="{CC3F8122-B306-4C44-9A39-9EB36E5446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F56985-B2F4-D946-993F-F387E79CA1D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350968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xmlns="" id="{4887446B-D7B8-5548-BEFA-5E3BF79870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xmlns="" id="{B1BF0123-DA79-D940-AE85-6AA4D0566E3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xmlns="" id="{798B3B7D-7404-2C40-8192-AB716EDC1E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461A81-977A-3C44-B9AA-252E0BC27F59}" type="datetimeFigureOut">
              <a:rPr lang="es-ES" smtClean="0"/>
              <a:t>02/03/2020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xmlns="" id="{732F0CA4-2951-A344-B32D-32ADE0B7EF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xmlns="" id="{B29650F3-59F3-7F41-ACBA-5EDB1898A1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F56985-B2F4-D946-993F-F387E79CA1D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637554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xmlns="" id="{EF86759E-7BD6-9547-9772-B41DF06978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xmlns="" id="{41EB2A2E-FCC2-3442-B415-7677FBBA538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xmlns="" id="{5632AB56-B868-8942-90E5-364580F6210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xmlns="" id="{C8B1C1F2-7E5C-3341-B284-F823B47C93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461A81-977A-3C44-B9AA-252E0BC27F59}" type="datetimeFigureOut">
              <a:rPr lang="es-ES" smtClean="0"/>
              <a:t>02/03/2020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xmlns="" id="{4FFD1F18-1CA7-E747-9B65-C5769FE1CD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xmlns="" id="{B377A1B5-6071-9B46-AE65-8DA25C3CBB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F56985-B2F4-D946-993F-F387E79CA1D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424287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xmlns="" id="{07204752-6574-154E-B8BB-D62B750B17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xmlns="" id="{23854906-2781-0A4A-979E-2739DDD9D60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xmlns="" id="{C651AF96-4675-6E4A-8390-3B6EFBF4D66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xmlns="" id="{A2732852-E5E2-9E48-9CF4-A0B67BE9805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xmlns="" id="{60D11A0A-869A-D148-8C90-A2CF63E8C86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xmlns="" id="{D0374CFA-D325-1B45-B578-768CC75495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461A81-977A-3C44-B9AA-252E0BC27F59}" type="datetimeFigureOut">
              <a:rPr lang="es-ES" smtClean="0"/>
              <a:t>02/03/2020</a:t>
            </a:fld>
            <a:endParaRPr lang="es-ES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xmlns="" id="{F21DCCF0-CA60-0444-BB1C-BAD789D673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xmlns="" id="{1B7EEB66-0A88-684D-93F5-8E4AAD9222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F56985-B2F4-D946-993F-F387E79CA1D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607471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xmlns="" id="{6BA2B7CE-ADEC-F647-AF8D-47799980BBA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xmlns="" id="{70AB27EB-8C7D-F443-8F42-CA5B204746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461A81-977A-3C44-B9AA-252E0BC27F59}" type="datetimeFigureOut">
              <a:rPr lang="es-ES" smtClean="0"/>
              <a:t>02/03/2020</a:t>
            </a:fld>
            <a:endParaRPr lang="es-ES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xmlns="" id="{CCB3E9BE-CD1E-554B-9D1B-567481DB2A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xmlns="" id="{BBD104CD-8AE1-9249-B19E-9D546DDB84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F56985-B2F4-D946-993F-F387E79CA1D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67209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xmlns="" id="{96C6B4F6-B381-C447-8501-126FD165CC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461A81-977A-3C44-B9AA-252E0BC27F59}" type="datetimeFigureOut">
              <a:rPr lang="es-ES" smtClean="0"/>
              <a:t>02/03/2020</a:t>
            </a:fld>
            <a:endParaRPr lang="es-ES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xmlns="" id="{EE39A8B4-2FAD-2C40-B5AC-3CFCF11AA9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xmlns="" id="{F402D2AA-FD32-3643-B762-B5EF109FCC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F56985-B2F4-D946-993F-F387E79CA1D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704823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xmlns="" id="{B322E6C3-C59B-F943-8DAE-5E09578EFF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xmlns="" id="{74CAEB82-5D90-C545-B1C7-CD711B813BD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xmlns="" id="{770F52D4-9AE6-9A48-B015-73BDC993CD6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xmlns="" id="{6FB6E425-9D1B-5B40-9373-DE64BA8F1D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461A81-977A-3C44-B9AA-252E0BC27F59}" type="datetimeFigureOut">
              <a:rPr lang="es-ES" smtClean="0"/>
              <a:t>02/03/2020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xmlns="" id="{4CDA23F9-78EA-174B-8867-E03E6D37B8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xmlns="" id="{79545613-8AB3-8141-82B2-AFEA13470A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F56985-B2F4-D946-993F-F387E79CA1D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577162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xmlns="" id="{D0FC1222-CC7D-6C43-AC0A-BC72442F38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xmlns="" id="{933AA0B1-46C5-ED48-9040-6095B89CF8D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xmlns="" id="{5422C24D-1514-2B4F-9141-700287E8CB2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xmlns="" id="{DD69B692-CEBF-604B-9B37-FBF5CB79E9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461A81-977A-3C44-B9AA-252E0BC27F59}" type="datetimeFigureOut">
              <a:rPr lang="es-ES" smtClean="0"/>
              <a:t>02/03/2020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xmlns="" id="{0A10A9CF-A212-134D-B062-AFAA8D7A11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xmlns="" id="{1C3BF326-2C43-A442-ACA2-1382523399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F56985-B2F4-D946-993F-F387E79CA1D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873112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xmlns="" id="{17AB81CA-3187-C749-B552-32427C258B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xmlns="" id="{D917B892-F9DF-6147-9D47-881188EA70A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xmlns="" id="{78E16CA6-264C-9C49-97BA-E90AA3AEDCB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461A81-977A-3C44-B9AA-252E0BC27F59}" type="datetimeFigureOut">
              <a:rPr lang="es-ES" smtClean="0"/>
              <a:t>02/03/2020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xmlns="" id="{853F938E-D6EA-9D4E-9D00-4A78EE02DDB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xmlns="" id="{02A13B52-FEA7-0444-98C1-E81211DE7B9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F56985-B2F4-D946-993F-F387E79CA1D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931421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>
            <a:extLst>
              <a:ext uri="{FF2B5EF4-FFF2-40B4-BE49-F238E27FC236}">
                <a16:creationId xmlns:a16="http://schemas.microsoft.com/office/drawing/2014/main" xmlns="" id="{BFB36E65-793C-3B43-AE80-463F508A41FD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s-ES"/>
          </a:p>
        </p:txBody>
      </p:sp>
      <p:sp>
        <p:nvSpPr>
          <p:cNvPr id="5" name="Rectangle 3">
            <a:extLst>
              <a:ext uri="{FF2B5EF4-FFF2-40B4-BE49-F238E27FC236}">
                <a16:creationId xmlns:a16="http://schemas.microsoft.com/office/drawing/2014/main" xmlns="" id="{6AAF9856-1EE8-B243-AC06-AF15B8C0D477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1539" y="2509004"/>
            <a:ext cx="11666541" cy="6463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algn="just" eaLnBrk="0" fontAlgn="base" hangingPunct="0">
              <a:lnSpc>
                <a:spcPct val="150000"/>
              </a:lnSpc>
              <a:spcBef>
                <a:spcPct val="0"/>
              </a:spcBef>
              <a:spcAft>
                <a:spcPts val="600"/>
              </a:spcAft>
            </a:pP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: Gating strategy followed to determine percentage of apoptotic cells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 representative dot plot is shown. To identify apoptotic cells the gating strategy was the follow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nglets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Lymphocytes, CD3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 cells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4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CD8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 cells and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poptotic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s for CD4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CD8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Annexin V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7AAD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Annexin V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7AAD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</a:t>
            </a:r>
            <a:r>
              <a:rPr kumimoji="0" lang="en-US" altLang="es-E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endParaRPr kumimoji="0" lang="en-US" altLang="es-E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CuadroTexto 7">
            <a:extLst>
              <a:ext uri="{FF2B5EF4-FFF2-40B4-BE49-F238E27FC236}">
                <a16:creationId xmlns:a16="http://schemas.microsoft.com/office/drawing/2014/main" xmlns="" id="{735F999A-9680-A740-BB68-3B454AC3C41E}"/>
              </a:ext>
            </a:extLst>
          </p:cNvPr>
          <p:cNvSpPr txBox="1"/>
          <p:nvPr/>
        </p:nvSpPr>
        <p:spPr>
          <a:xfrm rot="16200000">
            <a:off x="-89315" y="1052197"/>
            <a:ext cx="1252692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E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SC-H</a:t>
            </a:r>
          </a:p>
        </p:txBody>
      </p:sp>
      <p:sp>
        <p:nvSpPr>
          <p:cNvPr id="9" name="CuadroTexto 8">
            <a:extLst>
              <a:ext uri="{FF2B5EF4-FFF2-40B4-BE49-F238E27FC236}">
                <a16:creationId xmlns:a16="http://schemas.microsoft.com/office/drawing/2014/main" xmlns="" id="{ECF17EE4-69C2-8148-89DE-86440C77217C}"/>
              </a:ext>
            </a:extLst>
          </p:cNvPr>
          <p:cNvSpPr txBox="1"/>
          <p:nvPr/>
        </p:nvSpPr>
        <p:spPr>
          <a:xfrm rot="16200000">
            <a:off x="1761257" y="999409"/>
            <a:ext cx="1252692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E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SC-A</a:t>
            </a:r>
          </a:p>
        </p:txBody>
      </p:sp>
      <p:grpSp>
        <p:nvGrpSpPr>
          <p:cNvPr id="15" name="Grupo 14">
            <a:extLst>
              <a:ext uri="{FF2B5EF4-FFF2-40B4-BE49-F238E27FC236}">
                <a16:creationId xmlns:a16="http://schemas.microsoft.com/office/drawing/2014/main" xmlns="" id="{FFECE336-4EAB-9748-86A6-438C82CE0DBA}"/>
              </a:ext>
            </a:extLst>
          </p:cNvPr>
          <p:cNvGrpSpPr/>
          <p:nvPr/>
        </p:nvGrpSpPr>
        <p:grpSpPr>
          <a:xfrm>
            <a:off x="0" y="193363"/>
            <a:ext cx="11669486" cy="2445444"/>
            <a:chOff x="220133" y="228600"/>
            <a:chExt cx="11669486" cy="2445444"/>
          </a:xfrm>
        </p:grpSpPr>
        <p:pic>
          <p:nvPicPr>
            <p:cNvPr id="11" name="Imagen 10" descr="Imagen que contiene captura de pantalla&#10;&#10;Descripción generada automáticamente">
              <a:extLst>
                <a:ext uri="{FF2B5EF4-FFF2-40B4-BE49-F238E27FC236}">
                  <a16:creationId xmlns:a16="http://schemas.microsoft.com/office/drawing/2014/main" xmlns="" id="{FB03BF1A-3162-EB49-BAF0-757F6E985809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20133" y="228600"/>
              <a:ext cx="11669486" cy="2445444"/>
            </a:xfrm>
            <a:prstGeom prst="rect">
              <a:avLst/>
            </a:prstGeom>
          </p:spPr>
        </p:pic>
        <p:sp>
          <p:nvSpPr>
            <p:cNvPr id="12" name="CuadroTexto 11">
              <a:extLst>
                <a:ext uri="{FF2B5EF4-FFF2-40B4-BE49-F238E27FC236}">
                  <a16:creationId xmlns:a16="http://schemas.microsoft.com/office/drawing/2014/main" xmlns="" id="{3708A680-D3BF-0D47-BDD1-70997E426C4D}"/>
                </a:ext>
              </a:extLst>
            </p:cNvPr>
            <p:cNvSpPr txBox="1"/>
            <p:nvPr/>
          </p:nvSpPr>
          <p:spPr>
            <a:xfrm rot="16200000">
              <a:off x="-89315" y="1080177"/>
              <a:ext cx="1252692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s-E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SC-H</a:t>
              </a:r>
            </a:p>
          </p:txBody>
        </p:sp>
        <p:sp>
          <p:nvSpPr>
            <p:cNvPr id="13" name="CuadroTexto 12">
              <a:extLst>
                <a:ext uri="{FF2B5EF4-FFF2-40B4-BE49-F238E27FC236}">
                  <a16:creationId xmlns:a16="http://schemas.microsoft.com/office/drawing/2014/main" xmlns="" id="{69C8C4E2-73FC-6F40-A3B8-E69A8BC7BF66}"/>
                </a:ext>
              </a:extLst>
            </p:cNvPr>
            <p:cNvSpPr txBox="1"/>
            <p:nvPr/>
          </p:nvSpPr>
          <p:spPr>
            <a:xfrm rot="16200000">
              <a:off x="1761257" y="1027389"/>
              <a:ext cx="1252692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s-E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SC-A</a:t>
              </a:r>
            </a:p>
          </p:txBody>
        </p:sp>
        <p:sp>
          <p:nvSpPr>
            <p:cNvPr id="14" name="CuadroTexto 13">
              <a:extLst>
                <a:ext uri="{FF2B5EF4-FFF2-40B4-BE49-F238E27FC236}">
                  <a16:creationId xmlns:a16="http://schemas.microsoft.com/office/drawing/2014/main" xmlns="" id="{ABDA35EA-C604-5E41-ACD7-3D3CEF9ABCBA}"/>
                </a:ext>
              </a:extLst>
            </p:cNvPr>
            <p:cNvSpPr txBox="1"/>
            <p:nvPr/>
          </p:nvSpPr>
          <p:spPr>
            <a:xfrm rot="16200000">
              <a:off x="3669383" y="1016010"/>
              <a:ext cx="1252692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s-E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SC-H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73449249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ángulo 3">
            <a:extLst>
              <a:ext uri="{FF2B5EF4-FFF2-40B4-BE49-F238E27FC236}">
                <a16:creationId xmlns:a16="http://schemas.microsoft.com/office/drawing/2014/main" xmlns="" id="{57C8A89C-F1BE-5A42-B409-B403AE133705}"/>
              </a:ext>
            </a:extLst>
          </p:cNvPr>
          <p:cNvSpPr/>
          <p:nvPr/>
        </p:nvSpPr>
        <p:spPr>
          <a:xfrm>
            <a:off x="125727" y="2496326"/>
            <a:ext cx="11607258" cy="61677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600"/>
              </a:spcAft>
            </a:pP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2: gating strategy followed to determine T-cell subpopulations, activation, exhaustion and cytokine production.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 representative dot plot is shown. The gating strategy was the follow: Singlets, Lymphocytes , CD3</a:t>
            </a:r>
            <a:r>
              <a:rPr lang="en-US" sz="12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T cells, CD4</a:t>
            </a:r>
            <a:r>
              <a:rPr lang="en-US" sz="12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CD8</a:t>
            </a:r>
            <a:r>
              <a:rPr lang="en-US" sz="12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T cells and CCR7 and CD45R was used to define memory cells. </a:t>
            </a:r>
            <a:endParaRPr lang="es-E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pSp>
        <p:nvGrpSpPr>
          <p:cNvPr id="9" name="Grupo 8"/>
          <p:cNvGrpSpPr/>
          <p:nvPr/>
        </p:nvGrpSpPr>
        <p:grpSpPr>
          <a:xfrm>
            <a:off x="207663" y="297747"/>
            <a:ext cx="11679907" cy="2263478"/>
            <a:chOff x="207663" y="347637"/>
            <a:chExt cx="11679907" cy="2263478"/>
          </a:xfrm>
        </p:grpSpPr>
        <p:grpSp>
          <p:nvGrpSpPr>
            <p:cNvPr id="3" name="Grupo 2">
              <a:extLst>
                <a:ext uri="{FF2B5EF4-FFF2-40B4-BE49-F238E27FC236}">
                  <a16:creationId xmlns:a16="http://schemas.microsoft.com/office/drawing/2014/main" xmlns="" id="{8B42FDBF-6CE8-7F41-809D-CC1DC406F970}"/>
                </a:ext>
              </a:extLst>
            </p:cNvPr>
            <p:cNvGrpSpPr/>
            <p:nvPr/>
          </p:nvGrpSpPr>
          <p:grpSpPr>
            <a:xfrm>
              <a:off x="207663" y="347637"/>
              <a:ext cx="11679907" cy="2263478"/>
              <a:chOff x="280086" y="312068"/>
              <a:chExt cx="7962912" cy="1543152"/>
            </a:xfrm>
          </p:grpSpPr>
          <p:pic>
            <p:nvPicPr>
              <p:cNvPr id="6" name="Imagen 5">
                <a:extLst>
                  <a:ext uri="{FF2B5EF4-FFF2-40B4-BE49-F238E27FC236}">
                    <a16:creationId xmlns:a16="http://schemas.microsoft.com/office/drawing/2014/main" xmlns="" id="{C5FB7118-EC29-E546-941A-6920F34FBE5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b="76592"/>
              <a:stretch/>
            </p:blipFill>
            <p:spPr>
              <a:xfrm>
                <a:off x="280086" y="365125"/>
                <a:ext cx="7728718" cy="1456219"/>
              </a:xfrm>
              <a:prstGeom prst="rect">
                <a:avLst/>
              </a:prstGeom>
            </p:spPr>
          </p:pic>
          <p:grpSp>
            <p:nvGrpSpPr>
              <p:cNvPr id="2" name="Grupo 1">
                <a:extLst>
                  <a:ext uri="{FF2B5EF4-FFF2-40B4-BE49-F238E27FC236}">
                    <a16:creationId xmlns:a16="http://schemas.microsoft.com/office/drawing/2014/main" xmlns="" id="{C62C3781-2103-0E4C-9592-D07D6BAE3F20}"/>
                  </a:ext>
                </a:extLst>
              </p:cNvPr>
              <p:cNvGrpSpPr/>
              <p:nvPr/>
            </p:nvGrpSpPr>
            <p:grpSpPr>
              <a:xfrm>
                <a:off x="785148" y="312068"/>
                <a:ext cx="7457850" cy="1543152"/>
                <a:chOff x="785148" y="312068"/>
                <a:chExt cx="7457850" cy="1543152"/>
              </a:xfrm>
            </p:grpSpPr>
            <p:sp>
              <p:nvSpPr>
                <p:cNvPr id="7" name="CuadroTexto 6">
                  <a:extLst>
                    <a:ext uri="{FF2B5EF4-FFF2-40B4-BE49-F238E27FC236}">
                      <a16:creationId xmlns:a16="http://schemas.microsoft.com/office/drawing/2014/main" xmlns="" id="{88712BB2-E3B8-C446-8240-8D36B60A012D}"/>
                    </a:ext>
                  </a:extLst>
                </p:cNvPr>
                <p:cNvSpPr txBox="1"/>
                <p:nvPr/>
              </p:nvSpPr>
              <p:spPr>
                <a:xfrm>
                  <a:off x="785148" y="1575123"/>
                  <a:ext cx="1252692" cy="246221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r>
                    <a:rPr lang="es-ES" sz="10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FSC-A</a:t>
                  </a:r>
                </a:p>
              </p:txBody>
            </p:sp>
            <p:sp>
              <p:nvSpPr>
                <p:cNvPr id="8" name="CuadroTexto 7">
                  <a:extLst>
                    <a:ext uri="{FF2B5EF4-FFF2-40B4-BE49-F238E27FC236}">
                      <a16:creationId xmlns:a16="http://schemas.microsoft.com/office/drawing/2014/main" xmlns="" id="{ED9D24C0-F7BE-B742-9828-ED396C0596AD}"/>
                    </a:ext>
                  </a:extLst>
                </p:cNvPr>
                <p:cNvSpPr txBox="1"/>
                <p:nvPr/>
              </p:nvSpPr>
              <p:spPr>
                <a:xfrm>
                  <a:off x="2037840" y="1575123"/>
                  <a:ext cx="1252692" cy="246221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r>
                    <a:rPr lang="es-ES" sz="10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FSC-A</a:t>
                  </a:r>
                </a:p>
              </p:txBody>
            </p:sp>
            <p:sp>
              <p:nvSpPr>
                <p:cNvPr id="13" name="CuadroTexto 12">
                  <a:extLst>
                    <a:ext uri="{FF2B5EF4-FFF2-40B4-BE49-F238E27FC236}">
                      <a16:creationId xmlns:a16="http://schemas.microsoft.com/office/drawing/2014/main" xmlns="" id="{4580E0BC-D44E-2441-9292-1AF860C8A4E1}"/>
                    </a:ext>
                  </a:extLst>
                </p:cNvPr>
                <p:cNvSpPr txBox="1"/>
                <p:nvPr/>
              </p:nvSpPr>
              <p:spPr>
                <a:xfrm>
                  <a:off x="3232230" y="1608999"/>
                  <a:ext cx="1310994" cy="246221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r>
                    <a:rPr lang="es-ES" sz="10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D14/CD19</a:t>
                  </a:r>
                </a:p>
              </p:txBody>
            </p:sp>
            <p:sp>
              <p:nvSpPr>
                <p:cNvPr id="14" name="CuadroTexto 13">
                  <a:extLst>
                    <a:ext uri="{FF2B5EF4-FFF2-40B4-BE49-F238E27FC236}">
                      <a16:creationId xmlns:a16="http://schemas.microsoft.com/office/drawing/2014/main" xmlns="" id="{F998AFFB-93FB-3F41-9D62-9E8983A5439B}"/>
                    </a:ext>
                  </a:extLst>
                </p:cNvPr>
                <p:cNvSpPr txBox="1"/>
                <p:nvPr/>
              </p:nvSpPr>
              <p:spPr>
                <a:xfrm>
                  <a:off x="4543224" y="1583797"/>
                  <a:ext cx="1252692" cy="246221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r>
                    <a:rPr lang="es-ES" sz="10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  CD4</a:t>
                  </a:r>
                </a:p>
              </p:txBody>
            </p:sp>
            <p:sp>
              <p:nvSpPr>
                <p:cNvPr id="15" name="CuadroTexto 14">
                  <a:extLst>
                    <a:ext uri="{FF2B5EF4-FFF2-40B4-BE49-F238E27FC236}">
                      <a16:creationId xmlns:a16="http://schemas.microsoft.com/office/drawing/2014/main" xmlns="" id="{B367745C-DFA2-2949-BD88-E55209D72E0E}"/>
                    </a:ext>
                  </a:extLst>
                </p:cNvPr>
                <p:cNvSpPr txBox="1"/>
                <p:nvPr/>
              </p:nvSpPr>
              <p:spPr>
                <a:xfrm>
                  <a:off x="5766765" y="1574986"/>
                  <a:ext cx="1252692" cy="246221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r>
                    <a:rPr lang="es-ES" sz="10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D45RA</a:t>
                  </a:r>
                </a:p>
              </p:txBody>
            </p:sp>
            <p:sp>
              <p:nvSpPr>
                <p:cNvPr id="16" name="CuadroTexto 15">
                  <a:extLst>
                    <a:ext uri="{FF2B5EF4-FFF2-40B4-BE49-F238E27FC236}">
                      <a16:creationId xmlns:a16="http://schemas.microsoft.com/office/drawing/2014/main" xmlns="" id="{28210759-6386-4947-9D01-5EED5E9D36B3}"/>
                    </a:ext>
                  </a:extLst>
                </p:cNvPr>
                <p:cNvSpPr txBox="1"/>
                <p:nvPr/>
              </p:nvSpPr>
              <p:spPr>
                <a:xfrm>
                  <a:off x="6990306" y="1590061"/>
                  <a:ext cx="1252692" cy="246221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r>
                    <a:rPr lang="es-ES" sz="10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D45RA</a:t>
                  </a:r>
                </a:p>
              </p:txBody>
            </p:sp>
            <p:sp>
              <p:nvSpPr>
                <p:cNvPr id="17" name="CuadroTexto 16">
                  <a:extLst>
                    <a:ext uri="{FF2B5EF4-FFF2-40B4-BE49-F238E27FC236}">
                      <a16:creationId xmlns:a16="http://schemas.microsoft.com/office/drawing/2014/main" xmlns="" id="{3B76F8A3-2231-4B4D-8273-796A80E2C020}"/>
                    </a:ext>
                  </a:extLst>
                </p:cNvPr>
                <p:cNvSpPr txBox="1"/>
                <p:nvPr/>
              </p:nvSpPr>
              <p:spPr>
                <a:xfrm rot="16200000">
                  <a:off x="2431206" y="748981"/>
                  <a:ext cx="909559" cy="167864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r>
                    <a:rPr lang="es-ES" sz="10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  CD3</a:t>
                  </a:r>
                  <a:endParaRPr lang="es-ES" sz="10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8" name="CuadroTexto 17">
                  <a:extLst>
                    <a:ext uri="{FF2B5EF4-FFF2-40B4-BE49-F238E27FC236}">
                      <a16:creationId xmlns:a16="http://schemas.microsoft.com/office/drawing/2014/main" xmlns="" id="{337E3894-F0AB-C34B-A807-7DDACA09F6F8}"/>
                    </a:ext>
                  </a:extLst>
                </p:cNvPr>
                <p:cNvSpPr txBox="1"/>
                <p:nvPr/>
              </p:nvSpPr>
              <p:spPr>
                <a:xfrm rot="16200000">
                  <a:off x="3750686" y="760673"/>
                  <a:ext cx="909559" cy="167864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r>
                    <a:rPr lang="es-ES" sz="10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  CD8</a:t>
                  </a:r>
                  <a:endParaRPr lang="es-ES" sz="10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9" name="CuadroTexto 18">
                  <a:extLst>
                    <a:ext uri="{FF2B5EF4-FFF2-40B4-BE49-F238E27FC236}">
                      <a16:creationId xmlns:a16="http://schemas.microsoft.com/office/drawing/2014/main" xmlns="" id="{BD38E5D2-4559-4943-843B-4FC28C27C0D1}"/>
                    </a:ext>
                  </a:extLst>
                </p:cNvPr>
                <p:cNvSpPr txBox="1"/>
                <p:nvPr/>
              </p:nvSpPr>
              <p:spPr>
                <a:xfrm rot="16200000">
                  <a:off x="5045711" y="784721"/>
                  <a:ext cx="909559" cy="167864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r>
                    <a:rPr lang="es-ES" sz="10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 CCR7 </a:t>
                  </a:r>
                  <a:endParaRPr lang="es-ES" sz="10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0" name="CuadroTexto 19">
                  <a:extLst>
                    <a:ext uri="{FF2B5EF4-FFF2-40B4-BE49-F238E27FC236}">
                      <a16:creationId xmlns:a16="http://schemas.microsoft.com/office/drawing/2014/main" xmlns="" id="{90934D0C-A2AA-3C45-B132-8F10770DB309}"/>
                    </a:ext>
                  </a:extLst>
                </p:cNvPr>
                <p:cNvSpPr txBox="1"/>
                <p:nvPr/>
              </p:nvSpPr>
              <p:spPr>
                <a:xfrm rot="16200000">
                  <a:off x="6493908" y="895419"/>
                  <a:ext cx="724735" cy="167864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r>
                    <a:rPr lang="es-ES" sz="10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 CCR7</a:t>
                  </a:r>
                  <a:endParaRPr lang="es-ES" sz="10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1" name="CuadroTexto 20">
                  <a:extLst>
                    <a:ext uri="{FF2B5EF4-FFF2-40B4-BE49-F238E27FC236}">
                      <a16:creationId xmlns:a16="http://schemas.microsoft.com/office/drawing/2014/main" xmlns="" id="{AB985B27-44E2-FD45-BB18-9FB2E92D2415}"/>
                    </a:ext>
                  </a:extLst>
                </p:cNvPr>
                <p:cNvSpPr txBox="1"/>
                <p:nvPr/>
              </p:nvSpPr>
              <p:spPr>
                <a:xfrm>
                  <a:off x="5586766" y="312068"/>
                  <a:ext cx="1252692" cy="246221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r>
                    <a:rPr lang="es-ES" sz="10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  CD8+ T </a:t>
                  </a:r>
                  <a:r>
                    <a:rPr lang="es-ES" sz="1000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ells</a:t>
                  </a:r>
                  <a:endParaRPr lang="es-ES" sz="10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2" name="CuadroTexto 21">
                  <a:extLst>
                    <a:ext uri="{FF2B5EF4-FFF2-40B4-BE49-F238E27FC236}">
                      <a16:creationId xmlns:a16="http://schemas.microsoft.com/office/drawing/2014/main" xmlns="" id="{5FBC06F4-8945-0349-BFC6-DD4D537E4A5B}"/>
                    </a:ext>
                  </a:extLst>
                </p:cNvPr>
                <p:cNvSpPr txBox="1"/>
                <p:nvPr/>
              </p:nvSpPr>
              <p:spPr>
                <a:xfrm>
                  <a:off x="6884916" y="312068"/>
                  <a:ext cx="1252692" cy="246221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r>
                    <a:rPr lang="es-ES" sz="10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  CD4+ T </a:t>
                  </a:r>
                  <a:r>
                    <a:rPr lang="es-ES" sz="1000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ells</a:t>
                  </a:r>
                  <a:endParaRPr lang="es-ES" sz="10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sp>
          <p:nvSpPr>
            <p:cNvPr id="24" name="CuadroTexto 23">
              <a:extLst>
                <a:ext uri="{FF2B5EF4-FFF2-40B4-BE49-F238E27FC236}">
                  <a16:creationId xmlns:a16="http://schemas.microsoft.com/office/drawing/2014/main" xmlns="" id="{337E3894-F0AB-C34B-A807-7DDACA09F6F8}"/>
                </a:ext>
              </a:extLst>
            </p:cNvPr>
            <p:cNvSpPr txBox="1"/>
            <p:nvPr/>
          </p:nvSpPr>
          <p:spPr>
            <a:xfrm rot="16200000">
              <a:off x="1511691" y="988496"/>
              <a:ext cx="1334131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s-ES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SSC-A</a:t>
              </a:r>
              <a:endParaRPr lang="es-E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CuadroTexto 24">
              <a:extLst>
                <a:ext uri="{FF2B5EF4-FFF2-40B4-BE49-F238E27FC236}">
                  <a16:creationId xmlns:a16="http://schemas.microsoft.com/office/drawing/2014/main" xmlns="" id="{337E3894-F0AB-C34B-A807-7DDACA09F6F8}"/>
                </a:ext>
              </a:extLst>
            </p:cNvPr>
            <p:cNvSpPr txBox="1"/>
            <p:nvPr/>
          </p:nvSpPr>
          <p:spPr>
            <a:xfrm rot="16200000">
              <a:off x="-322791" y="988495"/>
              <a:ext cx="1334131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s-ES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FSC-H</a:t>
              </a:r>
              <a:endParaRPr lang="es-E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09458381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ángulo 3">
            <a:extLst>
              <a:ext uri="{FF2B5EF4-FFF2-40B4-BE49-F238E27FC236}">
                <a16:creationId xmlns:a16="http://schemas.microsoft.com/office/drawing/2014/main" xmlns="" id="{EA04D4FD-8EE9-D645-975F-9377F2CB6CE5}"/>
              </a:ext>
            </a:extLst>
          </p:cNvPr>
          <p:cNvSpPr/>
          <p:nvPr/>
        </p:nvSpPr>
        <p:spPr>
          <a:xfrm>
            <a:off x="168876" y="5231126"/>
            <a:ext cx="11373550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3: Expression of HLA-DR on T-cell subsets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rcentage of HLA-DR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xpressing CD8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A) and CD4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 cells (B). Classification of T cell subsets is based on CD45RA CCR7 expression (naïve: CCR7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45RA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EM:CCR7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45RA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TEMRA: CCR7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45RA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M: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CR7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45RA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P-values (* p&lt;0.05 ** p&lt;0.01 ***p&lt;0.001 **** p&lt;0.0001) are indicative for the corresponding timepoint compared with baseline.</a:t>
            </a:r>
            <a:endParaRPr lang="es-E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Imagen 4">
            <a:extLst>
              <a:ext uri="{FF2B5EF4-FFF2-40B4-BE49-F238E27FC236}">
                <a16:creationId xmlns:a16="http://schemas.microsoft.com/office/drawing/2014/main" xmlns="" id="{BE4D647C-66A4-8540-97D3-83E8C8009EDC}"/>
              </a:ext>
            </a:extLst>
          </p:cNvPr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8876" y="218209"/>
            <a:ext cx="9175173" cy="523112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4392274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ángulo 3">
            <a:extLst>
              <a:ext uri="{FF2B5EF4-FFF2-40B4-BE49-F238E27FC236}">
                <a16:creationId xmlns:a16="http://schemas.microsoft.com/office/drawing/2014/main" xmlns="" id="{B1B622EC-C41C-274D-B167-4CFDB161A190}"/>
              </a:ext>
            </a:extLst>
          </p:cNvPr>
          <p:cNvSpPr/>
          <p:nvPr/>
        </p:nvSpPr>
        <p:spPr>
          <a:xfrm>
            <a:off x="168876" y="5463773"/>
            <a:ext cx="11854248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4: Levels of CD69</a:t>
            </a:r>
            <a:r>
              <a:rPr lang="en-US" sz="12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T-cell subsets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portion of CD8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A) and CD4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 cells (B) subsets expressing CD69. Classification of T cell subsets is based on CD45RA CCR7 expression (naïve: CCR7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45RA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EM:CCR7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45RA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TEMRA: CCR7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45RA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M: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CR7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45RA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dian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 interquartile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ange is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own. P-values (* p&lt;0.05 ** p&lt;0.01 ***p&lt;0.001 **** p&lt;0.0001) are indicative for the corresponding timepoint compared with baseline.</a:t>
            </a:r>
            <a:endParaRPr lang="es-E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Imagen 5">
            <a:extLst>
              <a:ext uri="{FF2B5EF4-FFF2-40B4-BE49-F238E27FC236}">
                <a16:creationId xmlns:a16="http://schemas.microsoft.com/office/drawing/2014/main" xmlns="" id="{96F52E65-3998-924C-9F48-348D94D69D8F}"/>
              </a:ext>
            </a:extLst>
          </p:cNvPr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8876" y="285075"/>
            <a:ext cx="8414015" cy="500389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322027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ángulo 3">
            <a:extLst>
              <a:ext uri="{FF2B5EF4-FFF2-40B4-BE49-F238E27FC236}">
                <a16:creationId xmlns:a16="http://schemas.microsoft.com/office/drawing/2014/main" xmlns="" id="{43195E8B-BBBD-B546-8BBE-E31AB8087D79}"/>
              </a:ext>
            </a:extLst>
          </p:cNvPr>
          <p:cNvSpPr/>
          <p:nvPr/>
        </p:nvSpPr>
        <p:spPr>
          <a:xfrm>
            <a:off x="120956" y="5614676"/>
            <a:ext cx="11654715" cy="61311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600"/>
              </a:spcAft>
            </a:pPr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5: Percentage of cells secreting cytokines. 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oportion of CD8</a:t>
            </a:r>
            <a:r>
              <a:rPr lang="en-US" sz="1200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A) and CD4</a:t>
            </a:r>
            <a:r>
              <a:rPr lang="en-US" sz="1200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T cells (B) secreting IFN-</a:t>
            </a:r>
            <a:r>
              <a:rPr lang="en-US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γ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IL-2, MIP1-β and TNF-α is shown. Median with interquartile range is shown. P-values (* p&lt;0.05 ** p&lt;0.01 ***p&lt;0.001 **** p&lt;0.0001) are indicative for the corresponding timepoint compared with baseline.</a:t>
            </a:r>
            <a:endParaRPr lang="es-ES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Imagen 4">
            <a:extLst>
              <a:ext uri="{FF2B5EF4-FFF2-40B4-BE49-F238E27FC236}">
                <a16:creationId xmlns:a16="http://schemas.microsoft.com/office/drawing/2014/main" xmlns="" id="{73527835-C843-BE4B-9F61-5FBCFC8AEC92}"/>
              </a:ext>
            </a:extLst>
          </p:cNvPr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0956" y="0"/>
            <a:ext cx="6280266" cy="561467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8662538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6544</TotalTime>
  <Words>388</Words>
  <Application>Microsoft Office PowerPoint</Application>
  <PresentationFormat>Panorámica</PresentationFormat>
  <Paragraphs>25</Paragraphs>
  <Slides>5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Tema de Office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íriam Rosás</dc:creator>
  <cp:lastModifiedBy>Miriam Rosas</cp:lastModifiedBy>
  <cp:revision>89</cp:revision>
  <dcterms:created xsi:type="dcterms:W3CDTF">2019-07-30T07:51:55Z</dcterms:created>
  <dcterms:modified xsi:type="dcterms:W3CDTF">2020-03-02T16:57:56Z</dcterms:modified>
</cp:coreProperties>
</file>